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72" r:id="rId2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8" userDrawn="1">
          <p15:clr>
            <a:srgbClr val="A4A3A4"/>
          </p15:clr>
        </p15:guide>
        <p15:guide id="2" pos="238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476" autoAdjust="0"/>
    <p:restoredTop sz="92986" autoAdjust="0"/>
  </p:normalViewPr>
  <p:slideViewPr>
    <p:cSldViewPr snapToGrid="0" snapToObjects="1">
      <p:cViewPr varScale="1">
        <p:scale>
          <a:sx n="59" d="100"/>
          <a:sy n="59" d="100"/>
        </p:scale>
        <p:origin x="2892" y="72"/>
      </p:cViewPr>
      <p:guideLst>
        <p:guide orient="horz" pos="3368"/>
        <p:guide pos="2381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2263235-826B-4DBE-BF6E-0C185A76ABA3}" type="datetimeFigureOut">
              <a:rPr lang="zh-CN" altLang="en-US" smtClean="0"/>
              <a:pPr/>
              <a:t>2018/8/2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150AFE5-DE01-4638-B01A-C45FD2F995A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84380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1pPr>
    <a:lvl2pPr marL="521437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2pPr>
    <a:lvl3pPr marL="104287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3pPr>
    <a:lvl4pPr marL="156431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4pPr>
    <a:lvl5pPr marL="2085746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5pPr>
    <a:lvl6pPr marL="260718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6pPr>
    <a:lvl7pPr marL="312862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7pPr>
    <a:lvl8pPr marL="3650056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8pPr>
    <a:lvl9pPr marL="417149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7688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98606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6154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06204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5531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56918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49961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49583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13072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90457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87272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1385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425" t="4617" r="20219" b="6874"/>
          <a:stretch/>
        </p:blipFill>
        <p:spPr>
          <a:xfrm>
            <a:off x="2749530" y="1520433"/>
            <a:ext cx="3283271" cy="4328284"/>
          </a:xfrm>
        </p:spPr>
      </p:pic>
      <p:sp>
        <p:nvSpPr>
          <p:cNvPr id="5" name="文本框 48"/>
          <p:cNvSpPr txBox="1"/>
          <p:nvPr/>
        </p:nvSpPr>
        <p:spPr>
          <a:xfrm>
            <a:off x="3633510" y="5886277"/>
            <a:ext cx="1252566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32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log10(</a:t>
            </a:r>
            <a:r>
              <a:rPr lang="en-US" altLang="zh-CN" sz="1323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value</a:t>
            </a:r>
            <a:r>
              <a:rPr lang="en-US" altLang="zh-CN" sz="132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sz="1323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48"/>
          <p:cNvSpPr txBox="1"/>
          <p:nvPr/>
        </p:nvSpPr>
        <p:spPr>
          <a:xfrm>
            <a:off x="3063357" y="1281511"/>
            <a:ext cx="2648440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32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most enriched GO terms</a:t>
            </a:r>
            <a:endParaRPr lang="zh-CN" altLang="en-US" sz="1323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2808520" y="5746882"/>
            <a:ext cx="41420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0 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26"/>
          <p:cNvSpPr txBox="1"/>
          <p:nvPr/>
        </p:nvSpPr>
        <p:spPr>
          <a:xfrm>
            <a:off x="3402227" y="5745967"/>
            <a:ext cx="300941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26"/>
          <p:cNvSpPr txBox="1"/>
          <p:nvPr/>
        </p:nvSpPr>
        <p:spPr>
          <a:xfrm>
            <a:off x="3998940" y="5756894"/>
            <a:ext cx="41998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26"/>
          <p:cNvSpPr txBox="1"/>
          <p:nvPr/>
        </p:nvSpPr>
        <p:spPr>
          <a:xfrm>
            <a:off x="4598311" y="5745713"/>
            <a:ext cx="41998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26"/>
          <p:cNvSpPr txBox="1"/>
          <p:nvPr/>
        </p:nvSpPr>
        <p:spPr>
          <a:xfrm>
            <a:off x="5193074" y="5748817"/>
            <a:ext cx="242018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5917279" y="3351400"/>
            <a:ext cx="2284845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23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logical process</a:t>
            </a:r>
            <a:endParaRPr lang="zh-CN" altLang="en-US" sz="132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5902439" y="3541130"/>
            <a:ext cx="2284845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23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ular component</a:t>
            </a:r>
            <a:endParaRPr lang="zh-CN" altLang="en-US" sz="132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48"/>
          <p:cNvSpPr txBox="1"/>
          <p:nvPr/>
        </p:nvSpPr>
        <p:spPr>
          <a:xfrm>
            <a:off x="5917263" y="3723160"/>
            <a:ext cx="2284845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323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lecular function</a:t>
            </a:r>
            <a:endParaRPr lang="zh-CN" altLang="en-US" sz="132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923681" y="1561589"/>
            <a:ext cx="1998791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rbohydrate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membrane transport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928620" y="1774053"/>
            <a:ext cx="1998791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ular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ponse to iron ion starvation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1867413" y="1971694"/>
            <a:ext cx="110458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Iron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ion transport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1778748" y="2179597"/>
            <a:ext cx="1104331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ponse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nitrate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1457382" y="2386721"/>
            <a:ext cx="145532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erol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synthetic proces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1407875" y="2601732"/>
            <a:ext cx="158386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Iron-sulfur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assembl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1926339" y="2818418"/>
            <a:ext cx="98987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Nitrate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port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2231896" y="3030883"/>
            <a:ext cx="63622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port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1037602" y="3228542"/>
            <a:ext cx="188829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assinosteroid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synthetic proces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1881867" y="3433595"/>
            <a:ext cx="99418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ed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rmination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1267557" y="3849295"/>
            <a:ext cx="162229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Fatty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id biosynthetic proces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1385942" y="3643229"/>
            <a:ext cx="1524753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Oxidation-reduction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ces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1467477" y="4063127"/>
            <a:ext cx="141499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NAD(P)H oxidase activit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826699" y="4267848"/>
            <a:ext cx="210408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gar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membrane transporter activit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1287475" y="4465488"/>
            <a:ext cx="1824658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NADH dehydrogenase activit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1202124" y="4688151"/>
            <a:ext cx="1820911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4-coumarate-CoA ligase activit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1481995" y="4885792"/>
            <a:ext cx="146024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Iron-sulfur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binding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1555415" y="5103915"/>
            <a:ext cx="1386939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nooxygenase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vit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1778748" y="5305917"/>
            <a:ext cx="111913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porter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vit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1163522" y="5522873"/>
            <a:ext cx="1820911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gral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onent of membrane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矩形 35"/>
          <p:cNvSpPr/>
          <p:nvPr/>
        </p:nvSpPr>
        <p:spPr>
          <a:xfrm>
            <a:off x="42402" y="363852"/>
            <a:ext cx="683200" cy="29591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323" b="1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Fig. </a:t>
            </a:r>
            <a:r>
              <a:rPr lang="en-US" altLang="zh-CN" sz="1323" b="1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S3</a:t>
            </a:r>
            <a:endParaRPr lang="en-US" altLang="zh-CN" sz="1323" b="1" dirty="0">
              <a:latin typeface="Times New Roman" panose="02020603050405020304" pitchFamily="18" charset="0"/>
              <a:ea typeface="Arial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5279092" y="1569000"/>
            <a:ext cx="22213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4015685" y="1784252"/>
            <a:ext cx="22213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3902030" y="1981891"/>
            <a:ext cx="22213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3842712" y="2201833"/>
            <a:ext cx="22213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3840234" y="2406885"/>
            <a:ext cx="22213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3830345" y="2611938"/>
            <a:ext cx="22213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3800959" y="2829641"/>
            <a:ext cx="22213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3634321" y="3031779"/>
            <a:ext cx="22213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3550858" y="3247030"/>
            <a:ext cx="22213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3543446" y="3453534"/>
            <a:ext cx="22213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/>
          <p:cNvSpPr txBox="1"/>
          <p:nvPr/>
        </p:nvSpPr>
        <p:spPr>
          <a:xfrm>
            <a:off x="3488984" y="3658877"/>
            <a:ext cx="36122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/>
          <p:cNvSpPr txBox="1"/>
          <p:nvPr/>
        </p:nvSpPr>
        <p:spPr>
          <a:xfrm>
            <a:off x="3458795" y="3864119"/>
            <a:ext cx="22213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/>
          <p:cNvSpPr txBox="1"/>
          <p:nvPr/>
        </p:nvSpPr>
        <p:spPr>
          <a:xfrm>
            <a:off x="4704095" y="4083792"/>
            <a:ext cx="22213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/>
          <p:cNvSpPr txBox="1"/>
          <p:nvPr/>
        </p:nvSpPr>
        <p:spPr>
          <a:xfrm>
            <a:off x="4701612" y="4288844"/>
            <a:ext cx="22213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/>
          <p:cNvSpPr txBox="1"/>
          <p:nvPr/>
        </p:nvSpPr>
        <p:spPr>
          <a:xfrm>
            <a:off x="4647264" y="4493897"/>
            <a:ext cx="22213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/>
          <p:cNvSpPr txBox="1"/>
          <p:nvPr/>
        </p:nvSpPr>
        <p:spPr>
          <a:xfrm>
            <a:off x="4529463" y="4705867"/>
            <a:ext cx="22213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/>
          <p:cNvSpPr txBox="1"/>
          <p:nvPr/>
        </p:nvSpPr>
        <p:spPr>
          <a:xfrm>
            <a:off x="4311597" y="4910005"/>
            <a:ext cx="22213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/>
          <p:cNvSpPr txBox="1"/>
          <p:nvPr/>
        </p:nvSpPr>
        <p:spPr>
          <a:xfrm>
            <a:off x="3808815" y="5125661"/>
            <a:ext cx="22213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54"/>
          <p:cNvSpPr txBox="1"/>
          <p:nvPr/>
        </p:nvSpPr>
        <p:spPr>
          <a:xfrm>
            <a:off x="3347726" y="5334931"/>
            <a:ext cx="22213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文本框 55"/>
          <p:cNvSpPr txBox="1"/>
          <p:nvPr/>
        </p:nvSpPr>
        <p:spPr>
          <a:xfrm>
            <a:off x="4381631" y="5537696"/>
            <a:ext cx="34074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9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20084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63</TotalTime>
  <Words>101</Words>
  <Application>Microsoft Office PowerPoint</Application>
  <PresentationFormat>自定义</PresentationFormat>
  <Paragraphs>5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Times New Roman</vt:lpstr>
      <vt:lpstr>Office Theme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yzyangyan</cp:lastModifiedBy>
  <cp:revision>159</cp:revision>
  <dcterms:created xsi:type="dcterms:W3CDTF">2017-02-03T22:12:08Z</dcterms:created>
  <dcterms:modified xsi:type="dcterms:W3CDTF">2018-08-23T04:40:06Z</dcterms:modified>
</cp:coreProperties>
</file>